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9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A1F33D-4319-9E41-A34F-8BC8F753C1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FD7EB09-FFC5-304A-B478-8D94293737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77A876-7734-A342-A3BA-8C96E59E1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8B94C5-F59E-1141-A8FC-70C4A28DB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1695A9-2C90-864C-822F-B49853B68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2431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C6E51C-73E2-8941-9D98-C8CB1E48F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26ED492-5AF0-E341-AD83-9733F38024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30892D-2FF5-0A43-84DC-3BBB31873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3899DB-02DD-1645-AF56-FAE0C8259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40955A-3E8B-5C43-8E39-DA241B9C9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90642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224DF43-3D2F-DD47-9E1F-9011F5E430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1A48EF-2C98-C04D-9B23-77BAE7FB52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511B47-4B5D-3D49-AC54-5041CF414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4347FB-2989-4643-9E50-BEE16B09F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BD2E5D-0042-AF43-AF5E-2CE1269CD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0987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0A40BC-C009-7943-9405-67C8AAAC19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807B3FC-2FB1-BC4C-8121-5FB7447275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6E2A72-86B6-A647-823F-9BB73F65A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1126E2-5AB0-444D-A3BC-7E9A71552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D264F0-1671-3440-A722-CABD6D777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6153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8AE04A-C3BB-3D42-AAF2-4EEC5CE04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0F11EA4-449D-324E-B444-73199CEB7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16FC1E-9BC9-714A-8B6C-C8EFCEF14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0C1A32-4B6D-C840-989B-8E624FEFD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3B3430-ADF8-AA49-B2A5-ED0616240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86223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1C98ED-FB6B-6A4E-A6B2-AB01C5C3E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A4051F-8F20-D842-8898-55EC750639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19EB774-6F0A-0147-AA12-E89AEDA5BD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909DF8-D713-714E-9654-B12EAFC88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576E05-2CE9-D447-BF9C-41291E6FF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E0BFF2-8952-D845-825B-1E9C3951A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6325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9EAFAC-7D38-1144-B77F-2F4D41C99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A695508-199C-0549-AF49-4908B4D96D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F583530-11C3-AB49-9E72-858D63B67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1E6B6B6-BFE2-B545-8CBE-62BFC737D8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3B933BE-2CFA-9846-A5ED-A5810A764A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2EDD68-D0B8-4348-AD0C-36445EE62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5B6A307-2EDF-714F-8EAF-AD87AB40C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B93EA0-50B2-1B41-9CD7-B5470ACC1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74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077F53-53C6-5B4E-98E4-6D72D3DF44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9B872E3-0922-3B41-B104-674EF4FB5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F6FB91C-51B6-8B4E-9931-78FFE527C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736DD5B-9446-CB4D-BC58-CD2BD718C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928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FAAA982-89CA-1A4B-A975-186443F1B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9A3D1EE-F0AA-8F4A-B44E-1D989CC10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6AC7FE5-B86E-504A-9579-604810136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2754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AC9ECE-59E7-6F46-9294-E566D022C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888EEF-36BE-414A-AADC-2CD58A049F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68F5CC-29DB-1B41-AEE6-AF83BF586D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2D60321-C8D0-D340-8C04-3D50D8E27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403AA6E-5A6A-E446-B4B0-CFD03D8EA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205E4F-B485-3A45-85E8-F251E5FE3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0877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7469DC-3529-4941-A97D-E7FBD8D03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BFBD057-0140-0242-95A3-6998D72338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BC257DB-7BFF-2242-8232-D37E8C22C0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B1A03B-7AC0-FD44-906F-99B158D81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8FDD543-7BE5-154C-8EC5-37649D8C9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977D07-078B-B144-8623-9510741A2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83534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35E2A87-B55E-9A47-960F-EC4DA3B3F5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E57254A-E36D-1C47-8221-441737F38A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C23E9C-8DA0-A34C-A31F-AAC7C3EA55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489C7-F358-B147-8EEC-9DC14A5427FF}" type="datetimeFigureOut">
              <a:rPr kumimoji="1" lang="zh-CN" altLang="en-US" smtClean="0"/>
              <a:t>2019/7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4FA76D-49FA-6848-8AB0-B2CC712565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D3A33B-2AF2-9849-8757-0C41F6584F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F443A-F587-CD4A-BE14-2ECB9FBF592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322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246981D7-2392-9B4E-8B57-F85DDF82D6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4255" y="1015204"/>
            <a:ext cx="1807287" cy="155179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87F37FB-3395-8C42-9484-9FF39639C0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28460" y="1015204"/>
            <a:ext cx="1932474" cy="155179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467F0FBE-A0A5-4546-B3E3-A5FB4E704D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44104" y="1028290"/>
            <a:ext cx="1636711" cy="156515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F64632DB-0B2E-EA4E-887E-048C00A5AD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28260" y="3180708"/>
            <a:ext cx="1444551" cy="152645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D64BC8CF-F485-7041-935C-7662039BCAE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4048" y="3175205"/>
            <a:ext cx="1663297" cy="156471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4210CC0A-5BB3-844B-851B-3E3D34F8741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02007" y="3180449"/>
            <a:ext cx="1880703" cy="1562492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94D9C6DA-0315-854F-8F59-EBBAD8DAB71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14165" y="3175206"/>
            <a:ext cx="2009065" cy="1564718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09CAA4CC-BD10-8243-9094-F76FAA5EAA5F}"/>
              </a:ext>
            </a:extLst>
          </p:cNvPr>
          <p:cNvSpPr/>
          <p:nvPr/>
        </p:nvSpPr>
        <p:spPr>
          <a:xfrm>
            <a:off x="1848113" y="5652030"/>
            <a:ext cx="971721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ger sequencing chromatogram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playing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ense mutation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ongenital scoliosis </a:t>
            </a:r>
          </a:p>
          <a:p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ck arrows indicate nucleotide substitution positions</a:t>
            </a:r>
          </a:p>
        </p:txBody>
      </p:sp>
      <p:sp>
        <p:nvSpPr>
          <p:cNvPr id="31" name="上箭头 30">
            <a:extLst>
              <a:ext uri="{FF2B5EF4-FFF2-40B4-BE49-F238E27FC236}">
                <a16:creationId xmlns:a16="http://schemas.microsoft.com/office/drawing/2014/main" id="{53D0C3CB-18E6-6441-8288-5196CFFD350C}"/>
              </a:ext>
            </a:extLst>
          </p:cNvPr>
          <p:cNvSpPr/>
          <p:nvPr/>
        </p:nvSpPr>
        <p:spPr>
          <a:xfrm>
            <a:off x="4699933" y="2567000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上箭头 31">
            <a:extLst>
              <a:ext uri="{FF2B5EF4-FFF2-40B4-BE49-F238E27FC236}">
                <a16:creationId xmlns:a16="http://schemas.microsoft.com/office/drawing/2014/main" id="{82F2DCF9-F39E-744B-A6BE-1398F9476D60}"/>
              </a:ext>
            </a:extLst>
          </p:cNvPr>
          <p:cNvSpPr/>
          <p:nvPr/>
        </p:nvSpPr>
        <p:spPr>
          <a:xfrm>
            <a:off x="6786902" y="2574166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上箭头 32">
            <a:extLst>
              <a:ext uri="{FF2B5EF4-FFF2-40B4-BE49-F238E27FC236}">
                <a16:creationId xmlns:a16="http://schemas.microsoft.com/office/drawing/2014/main" id="{61755055-D1C9-6B45-951E-819FDF3A3751}"/>
              </a:ext>
            </a:extLst>
          </p:cNvPr>
          <p:cNvSpPr/>
          <p:nvPr/>
        </p:nvSpPr>
        <p:spPr>
          <a:xfrm>
            <a:off x="8726590" y="2623691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上箭头 33">
            <a:extLst>
              <a:ext uri="{FF2B5EF4-FFF2-40B4-BE49-F238E27FC236}">
                <a16:creationId xmlns:a16="http://schemas.microsoft.com/office/drawing/2014/main" id="{557432A4-D72A-424C-8B12-6F160DED5457}"/>
              </a:ext>
            </a:extLst>
          </p:cNvPr>
          <p:cNvSpPr/>
          <p:nvPr/>
        </p:nvSpPr>
        <p:spPr>
          <a:xfrm>
            <a:off x="9051142" y="4767058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上箭头 34">
            <a:extLst>
              <a:ext uri="{FF2B5EF4-FFF2-40B4-BE49-F238E27FC236}">
                <a16:creationId xmlns:a16="http://schemas.microsoft.com/office/drawing/2014/main" id="{1918FBB2-E626-F44F-8A12-AB49CF379DE8}"/>
              </a:ext>
            </a:extLst>
          </p:cNvPr>
          <p:cNvSpPr/>
          <p:nvPr/>
        </p:nvSpPr>
        <p:spPr>
          <a:xfrm>
            <a:off x="6852653" y="4778319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上箭头 35">
            <a:extLst>
              <a:ext uri="{FF2B5EF4-FFF2-40B4-BE49-F238E27FC236}">
                <a16:creationId xmlns:a16="http://schemas.microsoft.com/office/drawing/2014/main" id="{A6E2E2EF-FAFC-B043-9BE1-CD4A9DE6DD8E}"/>
              </a:ext>
            </a:extLst>
          </p:cNvPr>
          <p:cNvSpPr/>
          <p:nvPr/>
        </p:nvSpPr>
        <p:spPr>
          <a:xfrm>
            <a:off x="4406082" y="4754452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上箭头 36">
            <a:extLst>
              <a:ext uri="{FF2B5EF4-FFF2-40B4-BE49-F238E27FC236}">
                <a16:creationId xmlns:a16="http://schemas.microsoft.com/office/drawing/2014/main" id="{7A055469-8209-3C4F-988D-EF4A2AAF846C}"/>
              </a:ext>
            </a:extLst>
          </p:cNvPr>
          <p:cNvSpPr/>
          <p:nvPr/>
        </p:nvSpPr>
        <p:spPr>
          <a:xfrm>
            <a:off x="2526903" y="4754451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82CAD64-D6DF-2E4B-A821-92AAEB3DE78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36143" y="1028290"/>
            <a:ext cx="1744943" cy="1538710"/>
          </a:xfrm>
          <a:prstGeom prst="rect">
            <a:avLst/>
          </a:prstGeom>
        </p:spPr>
      </p:pic>
      <p:sp>
        <p:nvSpPr>
          <p:cNvPr id="38" name="上箭头 37">
            <a:extLst>
              <a:ext uri="{FF2B5EF4-FFF2-40B4-BE49-F238E27FC236}">
                <a16:creationId xmlns:a16="http://schemas.microsoft.com/office/drawing/2014/main" id="{216BA7F9-2B43-7A4D-B122-DA1ED37F914B}"/>
              </a:ext>
            </a:extLst>
          </p:cNvPr>
          <p:cNvSpPr/>
          <p:nvPr/>
        </p:nvSpPr>
        <p:spPr>
          <a:xfrm>
            <a:off x="2422275" y="2542040"/>
            <a:ext cx="147281" cy="191655"/>
          </a:xfrm>
          <a:prstGeom prst="up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14">
            <a:extLst>
              <a:ext uri="{FF2B5EF4-FFF2-40B4-BE49-F238E27FC236}">
                <a16:creationId xmlns:a16="http://schemas.microsoft.com/office/drawing/2014/main" id="{480BDB6F-7D2C-A04C-B539-9FAADC6DFF0A}"/>
              </a:ext>
            </a:extLst>
          </p:cNvPr>
          <p:cNvSpPr/>
          <p:nvPr/>
        </p:nvSpPr>
        <p:spPr>
          <a:xfrm>
            <a:off x="8463876" y="3391561"/>
            <a:ext cx="1174531" cy="5847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XH73: </a:t>
            </a:r>
          </a:p>
          <a:p>
            <a:pPr algn="ctr"/>
            <a:r>
              <a:rPr lang="en-US" altLang="zh-CN" sz="16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.2613A&gt;C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15">
            <a:extLst>
              <a:ext uri="{FF2B5EF4-FFF2-40B4-BE49-F238E27FC236}">
                <a16:creationId xmlns:a16="http://schemas.microsoft.com/office/drawing/2014/main" id="{DD6A2E30-324D-B443-B726-57AD3FF586A1}"/>
              </a:ext>
            </a:extLst>
          </p:cNvPr>
          <p:cNvSpPr/>
          <p:nvPr/>
        </p:nvSpPr>
        <p:spPr>
          <a:xfrm>
            <a:off x="3935538" y="3369016"/>
            <a:ext cx="120035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H579</a:t>
            </a:r>
            <a:r>
              <a:rPr lang="en-US" altLang="zh-CN" sz="16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</a:t>
            </a:r>
          </a:p>
          <a:p>
            <a:pPr algn="ctr"/>
            <a:r>
              <a:rPr lang="en-US" altLang="zh-CN" sz="16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.2613A&gt;C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21">
            <a:extLst>
              <a:ext uri="{FF2B5EF4-FFF2-40B4-BE49-F238E27FC236}">
                <a16:creationId xmlns:a16="http://schemas.microsoft.com/office/drawing/2014/main" id="{FEA7CBD0-D2F5-5040-B7D2-13992842BE91}"/>
              </a:ext>
            </a:extLst>
          </p:cNvPr>
          <p:cNvSpPr/>
          <p:nvPr/>
        </p:nvSpPr>
        <p:spPr>
          <a:xfrm>
            <a:off x="1439255" y="3376920"/>
            <a:ext cx="2244929" cy="5847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XH766: </a:t>
            </a:r>
          </a:p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3437T&gt;G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24">
            <a:extLst>
              <a:ext uri="{FF2B5EF4-FFF2-40B4-BE49-F238E27FC236}">
                <a16:creationId xmlns:a16="http://schemas.microsoft.com/office/drawing/2014/main" id="{0DABE587-0B3F-CC4B-A7DA-B279630C3917}"/>
              </a:ext>
            </a:extLst>
          </p:cNvPr>
          <p:cNvSpPr/>
          <p:nvPr/>
        </p:nvSpPr>
        <p:spPr>
          <a:xfrm>
            <a:off x="6348414" y="3385856"/>
            <a:ext cx="124378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H902: </a:t>
            </a:r>
          </a:p>
          <a:p>
            <a:pPr algn="ctr"/>
            <a:r>
              <a:rPr lang="en-US" altLang="zh-CN" sz="16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.6440G&gt;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 4">
            <a:extLst>
              <a:ext uri="{FF2B5EF4-FFF2-40B4-BE49-F238E27FC236}">
                <a16:creationId xmlns:a16="http://schemas.microsoft.com/office/drawing/2014/main" id="{9324389D-0507-984A-8C2E-111C48EB962E}"/>
              </a:ext>
            </a:extLst>
          </p:cNvPr>
          <p:cNvSpPr/>
          <p:nvPr/>
        </p:nvSpPr>
        <p:spPr>
          <a:xfrm>
            <a:off x="3987904" y="1259718"/>
            <a:ext cx="1585621" cy="5847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lvl="0" algn="ctr">
              <a:spcAft>
                <a:spcPts val="0"/>
              </a:spcAft>
              <a:buClr>
                <a:srgbClr val="00B050"/>
              </a:buClr>
              <a:buSzPts val="2000"/>
            </a:pP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H810: </a:t>
            </a:r>
          </a:p>
          <a:p>
            <a:pPr lvl="0" algn="ctr">
              <a:spcAft>
                <a:spcPts val="0"/>
              </a:spcAft>
              <a:buClr>
                <a:srgbClr val="00B050"/>
              </a:buClr>
              <a:buSzPts val="2000"/>
            </a:pP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.1456G&gt;T</a:t>
            </a:r>
            <a:endParaRPr lang="zh-CN" altLang="zh-CN" sz="16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2" name="矩形 10">
            <a:extLst>
              <a:ext uri="{FF2B5EF4-FFF2-40B4-BE49-F238E27FC236}">
                <a16:creationId xmlns:a16="http://schemas.microsoft.com/office/drawing/2014/main" id="{EF8880A1-A15D-0E42-8C56-0FCDD967856B}"/>
              </a:ext>
            </a:extLst>
          </p:cNvPr>
          <p:cNvSpPr/>
          <p:nvPr/>
        </p:nvSpPr>
        <p:spPr>
          <a:xfrm>
            <a:off x="6425399" y="1245243"/>
            <a:ext cx="1152880" cy="584775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algn="ctr"/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H156: </a:t>
            </a:r>
          </a:p>
          <a:p>
            <a:pPr algn="ctr"/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.1571C&gt;A</a:t>
            </a:r>
            <a:endParaRPr lang="zh-CN" altLang="zh-CN" sz="16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3" name="矩形 27">
            <a:extLst>
              <a:ext uri="{FF2B5EF4-FFF2-40B4-BE49-F238E27FC236}">
                <a16:creationId xmlns:a16="http://schemas.microsoft.com/office/drawing/2014/main" id="{28B053AF-F1CF-4A43-89D7-DACBFB36A423}"/>
              </a:ext>
            </a:extLst>
          </p:cNvPr>
          <p:cNvSpPr/>
          <p:nvPr/>
        </p:nvSpPr>
        <p:spPr>
          <a:xfrm>
            <a:off x="8322048" y="1260997"/>
            <a:ext cx="1204176" cy="5847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H441</a:t>
            </a:r>
            <a:r>
              <a:rPr lang="en-US" altLang="zh-CN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</a:p>
          <a:p>
            <a:pPr algn="ctr"/>
            <a:r>
              <a:rPr lang="en-US" altLang="zh-CN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6825C&gt;G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7">
            <a:extLst>
              <a:ext uri="{FF2B5EF4-FFF2-40B4-BE49-F238E27FC236}">
                <a16:creationId xmlns:a16="http://schemas.microsoft.com/office/drawing/2014/main" id="{0317DC4B-1D81-1B4F-81E9-30B015218703}"/>
              </a:ext>
            </a:extLst>
          </p:cNvPr>
          <p:cNvSpPr/>
          <p:nvPr/>
        </p:nvSpPr>
        <p:spPr>
          <a:xfrm>
            <a:off x="1895787" y="1229742"/>
            <a:ext cx="128791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H1162: 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284C&gt;G</a:t>
            </a:r>
          </a:p>
        </p:txBody>
      </p:sp>
    </p:spTree>
    <p:extLst>
      <p:ext uri="{BB962C8B-B14F-4D97-AF65-F5344CB8AC3E}">
        <p14:creationId xmlns:p14="http://schemas.microsoft.com/office/powerpoint/2010/main" val="1342801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77</Words>
  <Application>Microsoft Macintosh PowerPoint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o Lin</dc:creator>
  <cp:lastModifiedBy>Mao Lin</cp:lastModifiedBy>
  <cp:revision>25</cp:revision>
  <cp:lastPrinted>2019-07-11T03:14:16Z</cp:lastPrinted>
  <dcterms:created xsi:type="dcterms:W3CDTF">2019-05-05T12:11:36Z</dcterms:created>
  <dcterms:modified xsi:type="dcterms:W3CDTF">2019-07-11T06:59:09Z</dcterms:modified>
</cp:coreProperties>
</file>